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594"/>
    <p:restoredTop sz="96208"/>
  </p:normalViewPr>
  <p:slideViewPr>
    <p:cSldViewPr snapToGrid="0" snapToObjects="1">
      <p:cViewPr varScale="1">
        <p:scale>
          <a:sx n="116" d="100"/>
          <a:sy n="116" d="100"/>
        </p:scale>
        <p:origin x="200" y="2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2CB719-40E7-F14C-BC2D-5EFE89EC105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A9D8B9A-0679-0745-9176-1AC3620350F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DCE64F-2859-104A-B5D1-594E3DEA36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A8ADD1-441C-444E-84AA-0DD9AE5C7892}" type="datetimeFigureOut">
              <a:rPr lang="en-US" smtClean="0"/>
              <a:t>1/1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2482A5-431F-2142-99E5-374B4CEEED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6B0BF44-CB6A-B64E-927D-AB3BDD61A6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8320B-0BC8-1249-94AA-7D4F4AEEB3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69321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B76C98-D9F8-AF42-9548-313E11B963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908604E-E238-704E-937F-92DF15393A3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E7D8CE-D6BE-CB49-ACF3-222303FADE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A8ADD1-441C-444E-84AA-0DD9AE5C7892}" type="datetimeFigureOut">
              <a:rPr lang="en-US" smtClean="0"/>
              <a:t>1/1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6BDD57-75E1-824F-85F4-0702541158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2DA1EB-741E-0248-ACFF-9EEFB6ACAA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8320B-0BC8-1249-94AA-7D4F4AEEB3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07536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AD353E8-55DD-C04F-9724-7124A93A1BC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12CB704-0DD2-9646-B1C1-15A201DD8BC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426DD48-37CE-9640-ADC4-514056C5D1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A8ADD1-441C-444E-84AA-0DD9AE5C7892}" type="datetimeFigureOut">
              <a:rPr lang="en-US" smtClean="0"/>
              <a:t>1/1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F21EEE2-63E0-9E4D-ABFF-1628C220BC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E0637F0-245A-124F-987B-14195E825B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8320B-0BC8-1249-94AA-7D4F4AEEB3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81525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8C0F67-3D1C-D646-8E65-541A2A0D5B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819B3AF-8E37-8C4D-BA21-D18DB5E6B33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075B7D-30DB-964F-A847-18CAF0BCF9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A8ADD1-441C-444E-84AA-0DD9AE5C7892}" type="datetimeFigureOut">
              <a:rPr lang="en-US" smtClean="0"/>
              <a:t>1/1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D9ECD0-D735-2741-8375-E51A9A7F31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B3F915-8E6F-A14C-8648-F2C8213C84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8320B-0BC8-1249-94AA-7D4F4AEEB3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8815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472EB5-CE78-3843-844C-BAD7EFF275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FFD94BF-4030-C34C-903E-B53DEE974EF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2837F9-9F33-CC45-B412-D4CBC5B652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A8ADD1-441C-444E-84AA-0DD9AE5C7892}" type="datetimeFigureOut">
              <a:rPr lang="en-US" smtClean="0"/>
              <a:t>1/1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9DB060-8126-EC43-9013-1930B06995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50B0B7B-6C9F-DD47-B60A-2AC20FB82E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8320B-0BC8-1249-94AA-7D4F4AEEB3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171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350DEC-DB98-D442-8A12-0FDEF8A526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D861CBA-8906-8C4F-9277-CCABF7A7724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8DEFA52-FA20-4D4D-ACF8-4E12566DEFF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F4C0712-C40D-9044-BB41-A86A15B809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A8ADD1-441C-444E-84AA-0DD9AE5C7892}" type="datetimeFigureOut">
              <a:rPr lang="en-US" smtClean="0"/>
              <a:t>1/13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6266734-7C91-B94C-9A74-075D35C7FC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00B4E8E-1A04-3B40-AEF2-AD4D75A3D7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8320B-0BC8-1249-94AA-7D4F4AEEB3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01465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668772-C208-B24D-A350-AA67583BA3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E1FF2D0-9B1D-934D-AEFB-F68C3985861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98FC40E-AA64-4045-920E-365EFFB3111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2143D8F-4AD0-C54D-8519-6EA04DA948F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A3A4A4A-CFA0-DD45-A020-53EDCF567CB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9AB39FD-47E9-D248-95C9-84B18EB686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A8ADD1-441C-444E-84AA-0DD9AE5C7892}" type="datetimeFigureOut">
              <a:rPr lang="en-US" smtClean="0"/>
              <a:t>1/13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37479CC-7566-2247-912C-853379F830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AF30E49-9A3E-E343-81AE-A8E7255978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8320B-0BC8-1249-94AA-7D4F4AEEB3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73632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8BECFF-AEBB-F74A-A409-570E8B4618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10EB01B-781D-3B45-AC99-E94918E190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A8ADD1-441C-444E-84AA-0DD9AE5C7892}" type="datetimeFigureOut">
              <a:rPr lang="en-US" smtClean="0"/>
              <a:t>1/13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5C20109-A62F-C54B-BA0E-35DFD5B5EB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EA13F9E-8B92-AC4B-B95A-D751C06BED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8320B-0BC8-1249-94AA-7D4F4AEEB3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26064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16AE66E-761F-874E-B9A3-0D4061F48F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A8ADD1-441C-444E-84AA-0DD9AE5C7892}" type="datetimeFigureOut">
              <a:rPr lang="en-US" smtClean="0"/>
              <a:t>1/13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5AFC1C2-AF88-0D47-B2D7-63FD1108B3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38BB648-A7E8-F947-86C7-CCB10FC267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8320B-0BC8-1249-94AA-7D4F4AEEB3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76210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8236E3-1929-3044-9805-74D9570E9E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26FE9BC-628B-8B49-8B0E-1C0833256C3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584F7A8-3112-8A47-96A9-6E002A31CD9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90AE1AC-D2BB-6F49-8861-37B0A13D5A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A8ADD1-441C-444E-84AA-0DD9AE5C7892}" type="datetimeFigureOut">
              <a:rPr lang="en-US" smtClean="0"/>
              <a:t>1/13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32DE966-C236-084E-AB05-5F6508DDE9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9B99110-743B-4447-BF4E-79E00210EC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8320B-0BC8-1249-94AA-7D4F4AEEB3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86059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9E7FAA-FC87-3D4A-ACCD-B1EBAAADB3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CB03FE3-0EEE-5B47-B684-0571C3DE793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A2F68E7-0DEC-7642-9F43-56DE6A81BB1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BD3C3C7-8A7B-2048-AD9C-73938D3FD9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A8ADD1-441C-444E-84AA-0DD9AE5C7892}" type="datetimeFigureOut">
              <a:rPr lang="en-US" smtClean="0"/>
              <a:t>1/13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F7187BD-EB89-4F42-90C1-DD6B74DC85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14EB5A5-1D09-D64F-BBC9-3D626DFEE7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8320B-0BC8-1249-94AA-7D4F4AEEB3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85825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6023797-1EC3-4A41-832D-6513C91816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F986222-6FAC-E84A-A8A6-ECD45E63A9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B194374-F1D4-6F42-9717-8292E63AECC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A8ADD1-441C-444E-84AA-0DD9AE5C7892}" type="datetimeFigureOut">
              <a:rPr lang="en-US" smtClean="0"/>
              <a:t>1/1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8334108-D832-8742-9119-FCCA5DA59CA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6539C4-6A41-2348-9E63-4B928A79C6E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B8320B-0BC8-1249-94AA-7D4F4AEEB3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98166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>
            <a:extLst>
              <a:ext uri="{FF2B5EF4-FFF2-40B4-BE49-F238E27FC236}">
                <a16:creationId xmlns:a16="http://schemas.microsoft.com/office/drawing/2014/main" id="{C88EE1F6-A639-3D4D-9039-32B5253F3CF1}"/>
              </a:ext>
            </a:extLst>
          </p:cNvPr>
          <p:cNvSpPr/>
          <p:nvPr/>
        </p:nvSpPr>
        <p:spPr>
          <a:xfrm>
            <a:off x="217487" y="70452"/>
            <a:ext cx="11003280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>
                <a:latin typeface="Times New Roman" panose="02020603050405020304" pitchFamily="18" charset="0"/>
                <a:ea typeface="Times New Roman" panose="02020603050405020304" pitchFamily="18" charset="0"/>
              </a:rPr>
              <a:t>Figure S4: </a:t>
            </a:r>
            <a:r>
              <a:rPr lang="en-US" sz="20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(A) Adjusted overall survival by gender and (B) adjusted progression-free survival by gender.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D00E42CE-BBF4-2742-A5C0-9C50F73E98B7}"/>
              </a:ext>
            </a:extLst>
          </p:cNvPr>
          <p:cNvSpPr/>
          <p:nvPr/>
        </p:nvSpPr>
        <p:spPr>
          <a:xfrm>
            <a:off x="191466" y="1161785"/>
            <a:ext cx="574873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(A)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E12F16E3-CE6C-5342-A772-35AD903EE4B6}"/>
              </a:ext>
            </a:extLst>
          </p:cNvPr>
          <p:cNvSpPr/>
          <p:nvPr/>
        </p:nvSpPr>
        <p:spPr>
          <a:xfrm>
            <a:off x="6095217" y="1161785"/>
            <a:ext cx="574873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(B)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E66D046A-DB81-FE48-A2F3-04CE2287C87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83900" y="1561895"/>
            <a:ext cx="5029200" cy="502920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0E666853-13E0-3C4F-A9A0-2F18F5B80E5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8902" y="1561895"/>
            <a:ext cx="5029200" cy="5029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114681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4</TotalTime>
  <Words>27</Words>
  <Application>Microsoft Macintosh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urran, Thomas</dc:creator>
  <cp:lastModifiedBy>Curran, Thomas</cp:lastModifiedBy>
  <cp:revision>11</cp:revision>
  <dcterms:created xsi:type="dcterms:W3CDTF">2020-06-27T05:13:52Z</dcterms:created>
  <dcterms:modified xsi:type="dcterms:W3CDTF">2021-01-13T15:16:53Z</dcterms:modified>
</cp:coreProperties>
</file>